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D2DD5-6DB8-4D83-2C51-C66F996C83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5ED9C7-FEDE-5621-79AA-5FD237B178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63DFBF-FA0A-10A7-CF09-22F58BE6F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8827E4-C7E2-174B-B626-C22A728E5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45B506-0149-053F-7459-B30764232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077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767A7E-D5E1-E756-5551-D0ADC9CFCA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1C607D-5045-0B62-0FEC-483C5FFC32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BC7B28-1819-F871-026E-1425EF5BC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2EE8DE-0EB9-D6A7-2E43-135C1B513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0C887-46A3-C12D-D8E0-2D8142473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820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3DEAE1-F817-04FF-01A9-3E5016AEDD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5FBACE-B67C-7596-132D-6D85607FAA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E8F9B7-2293-043A-D61D-A70BCF46C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4C752E-5FE9-9505-BF9D-7C06A724B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167BD4-E721-FF77-BAA6-56595537F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438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1CCD2-B99E-2B9A-2681-EA06039B5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E64116-731C-1D31-7652-40D2F7145D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962486-DA2C-CFCE-F713-6AD26C697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3AD6BF-2A50-D3DA-79E8-091D01E78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F8B82-6394-1A87-D06C-7D007F1FB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973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A0444-0103-8BFF-AF00-883EAA203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A0F130-35B7-A431-401E-362054DB0A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892E45-E844-924A-1ADD-F17412901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25E16-1B4E-ECD9-150F-963F3AE6F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3434A4-FBA1-DA33-878C-CF138EB74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337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7EF00-4B30-FEBC-6C7F-C10722B4C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53F799-0ECB-6C67-F280-66FE985AE4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5E8CDB-3DF6-CA26-6237-C2CC91850A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FA8E84-AD8A-CBC7-5A86-712B192D4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54A8F9-E1CA-CEEA-F117-1E3911440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1DA8E9-6BFB-77F3-4C53-3B320783C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376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BD6DF-CE3F-5C66-2656-D7BC7C883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314D10-1AC4-D306-2654-9434660AA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8DDFBD-6535-5F7B-1503-E9D307AD78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FB4AFA-EB2F-B162-635B-9370D71EF8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7495F6-2711-5D2C-218E-3A172345C6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CCE97C-AF27-9B3F-C851-ACE03D69B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3C8C11-04E6-CC34-B9F0-D462B040D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89F20B-14F1-64CD-E1E3-E34E014AD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048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621B4-0EBF-FECF-0555-EA81799ADF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51980B-1774-FCC1-41FF-9FD429E31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36FD09-248F-1114-6481-BA316D073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754168-C0F8-8F8C-298E-A8DA3D207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47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FC4BE4-E297-96AA-5CA2-0F77DECEC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6CA160-4A98-9289-D8C5-B4117FD01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166D52-D6F2-727B-04E1-EF4FFEE0C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736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DE802-F85B-12AA-DC53-B4ED5C6B3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3538FC-DA0F-AFBB-6729-6EB5A3F4AB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28DEF3-A2F3-3CB5-9B9C-C8286602E8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88D006-FA1F-EB31-9A63-95576F9D7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1AE5A9-6992-7519-6666-DEEB8F0AB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45A958-77DD-CBBD-1E37-2BB606021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177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E5561-CC69-773D-4F30-B48BC6E7A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D19713-8DFC-279F-90E9-1DE4975DE0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AB3B69-546E-F6D4-98F0-AF19FD05B5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104BD6-2F43-6CF0-7D6F-E99657225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70EEEF-5380-1BE6-A73F-66E4D02AB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22E21E-812F-5B3C-56F3-B88BD5E28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469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5D3937-E5BC-90A9-A683-EF8575CE13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90B2DE-5D0F-C512-D7BA-E4DE3AAF04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A55B42-4789-7DB3-C21B-159FF53B9B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ECFDC-2AD5-9245-A482-15C3F41A134B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4DBB7-7D23-3089-4B98-A6EAD228ED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9D2D22-3F33-948F-31BC-BA9C8C64FB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EB1F2-4B10-2C41-9C47-4AD610AFD9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77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8D1A619-5E3B-F065-C512-2C597B0F6B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3133287"/>
              </p:ext>
            </p:extLst>
          </p:nvPr>
        </p:nvGraphicFramePr>
        <p:xfrm>
          <a:off x="590570" y="498056"/>
          <a:ext cx="5183505" cy="50749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67003">
                  <a:extLst>
                    <a:ext uri="{9D8B030D-6E8A-4147-A177-3AD203B41FA5}">
                      <a16:colId xmlns:a16="http://schemas.microsoft.com/office/drawing/2014/main" val="2095385596"/>
                    </a:ext>
                  </a:extLst>
                </a:gridCol>
                <a:gridCol w="3616502">
                  <a:extLst>
                    <a:ext uri="{9D8B030D-6E8A-4147-A177-3AD203B41FA5}">
                      <a16:colId xmlns:a16="http://schemas.microsoft.com/office/drawing/2014/main" val="2230751263"/>
                    </a:ext>
                  </a:extLst>
                </a:gridCol>
              </a:tblGrid>
              <a:tr h="13774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ll type label</a:t>
                      </a: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ortium led phenotype call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44302874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yofibroblas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yofibroblas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802452221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Fibroblas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Fibroblas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5479203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Prolif fibroblas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Active proliferating fibroblas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4075460619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Blood vesse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+mn-lt"/>
                        </a:rPr>
                        <a:t>Blood vessels including bronchial and pulmonary artery and vein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b"/>
                </a:tc>
                <a:extLst>
                  <a:ext uri="{0D108BD9-81ED-4DB2-BD59-A6C34878D82A}">
                    <a16:rowId xmlns:a16="http://schemas.microsoft.com/office/drawing/2014/main" val="3728993731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Endothelial cel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ainly alveolar capillaries but also some blood vesse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023416557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Prolif endothelial cel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Active repairing endothelial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11770579"/>
                  </a:ext>
                </a:extLst>
              </a:tr>
              <a:tr h="28929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Bronchial epi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Healthy </a:t>
                      </a:r>
                      <a:r>
                        <a:rPr lang="en-GB" sz="1200" u="none" strike="noStrike" dirty="0" err="1">
                          <a:effectLst/>
                          <a:latin typeface="+mn-lt"/>
                        </a:rPr>
                        <a:t>HLADR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bronchial epithelium. These are the only bronchial epithelium found in healthy lung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4043470739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Prolif alveolar epi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RAGE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Type II alveolar epithelium  and alveolar progenitor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646469014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Prolif bronchial epi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Active repairing bronchial epithelium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1036469814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 err="1">
                          <a:effectLst/>
                          <a:latin typeface="+mn-lt"/>
                        </a:rPr>
                        <a:t>HLADR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bronchial epi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 err="1">
                          <a:effectLst/>
                          <a:latin typeface="+mn-lt"/>
                        </a:rPr>
                        <a:t>HLADR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bronchial epi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261367009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HLADR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bronchial epi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Inflamed bronchial epithelium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110087391"/>
                  </a:ext>
                </a:extLst>
              </a:tr>
              <a:tr h="28929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ono PAI-1 ADJ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onocytes adjacent to PAI-1 expressing cells, typically activated/inflamed endothelium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65926668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Neut CD8 ADJ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5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Neutrophils adjacent to </a:t>
                      </a:r>
                      <a:r>
                        <a:rPr lang="en-GB" sz="1200" u="none" strike="noStrike" baseline="0" dirty="0">
                          <a:effectLst/>
                          <a:latin typeface="+mn-lt"/>
                        </a:rPr>
                        <a:t>CD107-GZB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baseline="0" dirty="0">
                          <a:effectLst/>
                          <a:latin typeface="+mn-lt"/>
                        </a:rPr>
                        <a:t>CD8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2575552501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5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iNeu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Least immature neutrophi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298682747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5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mid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iNeu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id immature neutrophi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2437846082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5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Neu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ost immmature neutrophil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3786952510"/>
                  </a:ext>
                </a:extLst>
              </a:tr>
              <a:tr h="16048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b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</a:t>
                      </a:r>
                      <a:r>
                        <a:rPr lang="en-GB" sz="1200" u="none" strike="noStrike" baseline="0" dirty="0">
                          <a:effectLst/>
                          <a:latin typeface="+mn-lt"/>
                        </a:rPr>
                        <a:t>0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+mn-lt"/>
                        </a:rPr>
                        <a:t>Possible mature neutrophils (but no CD15 expression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b"/>
                </a:tc>
                <a:extLst>
                  <a:ext uri="{0D108BD9-81ED-4DB2-BD59-A6C34878D82A}">
                    <a16:rowId xmlns:a16="http://schemas.microsoft.com/office/drawing/2014/main" val="2361782158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ac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4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IFN-</a:t>
                      </a:r>
                      <a:r>
                        <a:rPr lang="en-GB" sz="1200" u="none" strike="noStrike" baseline="0" dirty="0">
                          <a:effectLst/>
                          <a:latin typeface="Symbol" pitchFamily="2" charset="2"/>
                        </a:rPr>
                        <a:t>b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‘transitional’ macrophage (Least mature macrophage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2731247448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ac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4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mid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acrophage (Mid Mature macrophage)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extLst>
                  <a:ext uri="{0D108BD9-81ED-4DB2-BD59-A6C34878D82A}">
                    <a16:rowId xmlns:a16="http://schemas.microsoft.com/office/drawing/2014/main" val="2858554431"/>
                  </a:ext>
                </a:extLst>
              </a:tr>
              <a:tr h="2490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ac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u="none" strike="noStrike" dirty="0" err="1">
                          <a:effectLst/>
                          <a:latin typeface="+mn-lt"/>
                        </a:rPr>
                        <a:t>HLADR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4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 mature Macrophage (Most Mature macrophage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3539618592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BC946D16-B39F-1B43-7241-FE770CDF6B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5844722"/>
              </p:ext>
            </p:extLst>
          </p:nvPr>
        </p:nvGraphicFramePr>
        <p:xfrm>
          <a:off x="5880241" y="498056"/>
          <a:ext cx="5446140" cy="56119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73995">
                  <a:extLst>
                    <a:ext uri="{9D8B030D-6E8A-4147-A177-3AD203B41FA5}">
                      <a16:colId xmlns:a16="http://schemas.microsoft.com/office/drawing/2014/main" val="183599764"/>
                    </a:ext>
                  </a:extLst>
                </a:gridCol>
                <a:gridCol w="4272145">
                  <a:extLst>
                    <a:ext uri="{9D8B030D-6E8A-4147-A177-3AD203B41FA5}">
                      <a16:colId xmlns:a16="http://schemas.microsoft.com/office/drawing/2014/main" val="2998451115"/>
                    </a:ext>
                  </a:extLst>
                </a:gridCol>
              </a:tblGrid>
              <a:tr h="1936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ll type label</a:t>
                      </a:r>
                    </a:p>
                  </a:txBody>
                  <a:tcPr marL="6381" marR="6381" marT="638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ortium led phenotype call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020152876"/>
                  </a:ext>
                </a:extLst>
              </a:tr>
              <a:tr h="38855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ixed population of monocytes - some classical CCR2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68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onocytes , some intermediate(CD14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6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) , some Ki67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/mid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cytes (immature cycling monocytes); overall - most differentiated  monocyte. ‘Differentiation 'refers to differentiation to macrophag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4278919728"/>
                  </a:ext>
                </a:extLst>
              </a:tr>
              <a:tr h="251431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lassical monocytes, CCR2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-hi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68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cytes (mid differentiated monocyte)  Ki6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endParaRPr lang="en-GB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2260705230"/>
                  </a:ext>
                </a:extLst>
              </a:tr>
              <a:tr h="251431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lassical monocytes, CCR2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68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neg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onocytes (least differentiated monocyte)  Ki6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endParaRPr lang="en-GB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344341990"/>
                  </a:ext>
                </a:extLst>
              </a:tr>
              <a:tr h="28929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ono_CD31_ADJ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CR2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68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neg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onocytes (least differentiated monocyte)  Ki6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adjacent to endothelial cells. Some were monocytes with CD31 expression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079805816"/>
                  </a:ext>
                </a:extLst>
              </a:tr>
              <a:tr h="251431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-</a:t>
                      </a:r>
                      <a:r>
                        <a:rPr lang="en-GB" sz="1200" u="none" strike="noStrike" baseline="0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hi RAGE ADJ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45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 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expressing cells with no epithelial marker  and high RAGE expression. Possible resident alveolar macrophage adjacent to RAGE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alveolar epithelium; but no CD68 expression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88956129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8_CD31_ADJ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0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8 adjacent to endothelial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76250891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0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45RO effector memory cytotoxic CD8 T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07535076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0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45RO effector memory  CD8 T cells , likely  exhausted cytotoxic CD8 T cell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825402282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-g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 CD4 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45RO effector memory  activated CD4  T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335166794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4 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Non-activated CD4  </a:t>
                      </a:r>
                      <a:r>
                        <a:rPr lang="en-GB" sz="1200" u="none" strike="noStrike">
                          <a:effectLst/>
                          <a:latin typeface="+mn-lt"/>
                        </a:rPr>
                        <a:t>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440821841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0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+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4 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ytotoxic CD4 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3408594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 err="1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NK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Activated NK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2504014239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NK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NK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2086074197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 err="1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 err="1">
                          <a:effectLst/>
                          <a:latin typeface="+mn-lt"/>
                        </a:rPr>
                        <a:t>hi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AIT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Activated MAI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343258588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IFN-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g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lo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MAIT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MAIT cells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2600122252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V</a:t>
                      </a:r>
                      <a:r>
                        <a:rPr lang="en-GB" sz="1200" u="none" strike="noStrike" dirty="0">
                          <a:effectLst/>
                          <a:latin typeface="Symbol" pitchFamily="2" charset="2"/>
                        </a:rPr>
                        <a:t>a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7.2lo cell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AIT-like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3506839613"/>
                  </a:ext>
                </a:extLst>
              </a:tr>
              <a:tr h="14464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>
                          <a:effectLst/>
                          <a:latin typeface="+mn-lt"/>
                        </a:rPr>
                        <a:t>CD8_PAI_ADJ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CD107</a:t>
                      </a:r>
                      <a:r>
                        <a:rPr lang="en-GB" sz="1200" u="none" strike="noStrike" baseline="30000" dirty="0">
                          <a:effectLst/>
                          <a:latin typeface="+mn-lt"/>
                        </a:rPr>
                        <a:t>-</a:t>
                      </a:r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 CD8 adjacent to activated/repairing  endothelial cells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3809389185"/>
                  </a:ext>
                </a:extLst>
              </a:tr>
              <a:tr h="136138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egakaryocyt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+mn-lt"/>
                        </a:rPr>
                        <a:t>Megakaryocyt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81" marR="6381" marT="6381" marB="0"/>
                </a:tc>
                <a:extLst>
                  <a:ext uri="{0D108BD9-81ED-4DB2-BD59-A6C34878D82A}">
                    <a16:rowId xmlns:a16="http://schemas.microsoft.com/office/drawing/2014/main" val="121205862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F560B29-AAF1-B00B-4EFD-9D9B2BB1B783}"/>
              </a:ext>
            </a:extLst>
          </p:cNvPr>
          <p:cNvSpPr txBox="1"/>
          <p:nvPr/>
        </p:nvSpPr>
        <p:spPr>
          <a:xfrm>
            <a:off x="462337" y="5744274"/>
            <a:ext cx="5633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able S3. Expanded description of phenotype </a:t>
            </a:r>
            <a:r>
              <a:rPr lang="en-US" sz="1200"/>
              <a:t>of cell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92881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34</Words>
  <Application>Microsoft Macintosh PowerPoint</Application>
  <PresentationFormat>Widescreen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 2013 - 2022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, Ling-Pei (RTH) OUH</dc:creator>
  <cp:lastModifiedBy>Ho, Ling-Pei (RTH) OUH</cp:lastModifiedBy>
  <cp:revision>2</cp:revision>
  <dcterms:created xsi:type="dcterms:W3CDTF">2022-12-20T13:45:10Z</dcterms:created>
  <dcterms:modified xsi:type="dcterms:W3CDTF">2022-12-21T18:49:37Z</dcterms:modified>
</cp:coreProperties>
</file>